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8" r:id="rId2"/>
    <p:sldId id="283" r:id="rId3"/>
    <p:sldId id="284" r:id="rId4"/>
    <p:sldId id="285" r:id="rId5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E90E474-AA40-0547-8148-23EDFA8C7F40}">
          <p14:sldIdLst>
            <p14:sldId id="278"/>
            <p14:sldId id="283"/>
            <p14:sldId id="284"/>
            <p14:sldId id="285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922" autoAdjust="0"/>
  </p:normalViewPr>
  <p:slideViewPr>
    <p:cSldViewPr snapToGrid="0" snapToObjects="1" showGuides="1">
      <p:cViewPr>
        <p:scale>
          <a:sx n="100" d="100"/>
          <a:sy n="100" d="100"/>
        </p:scale>
        <p:origin x="-1744" y="13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A157D-C987-9647-8EFA-79CB5430D7C9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CCF4A7-2F8A-0B4A-9B39-AE0D624E8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4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67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175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86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3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123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7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81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960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315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655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252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27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81531" y="234053"/>
            <a:ext cx="6094938" cy="99411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Courier"/>
                <a:cs typeface="Courier"/>
              </a:rPr>
              <a:t>MdCUL1A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bCUL1 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avCUL1A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avCUL1B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iCUL1G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iCUL1C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hCUL1 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SpCUL1 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1 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2 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3A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3B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4           1 -----MSLPTKRSTFSAASASDDS--SYSSPPMKKAKNDLHHSPQHPNTADKVV---GFHME--------     52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1-like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3-like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4-like      1 MSHPHATAPKRPGHFSSSSAAASSPTSPAQPHMKKAKFPGSSSSSSSAAAPGVTEKNGLHVDPTAAAART     70</a:t>
            </a:r>
          </a:p>
          <a:p>
            <a:r>
              <a:rPr lang="en-US" altLang="ja-JP" sz="800" dirty="0">
                <a:latin typeface="Courier"/>
                <a:cs typeface="Courier"/>
              </a:rPr>
              <a:t>ScCDC53          1 ----------------------------------------------------------------------      1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                                                                          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      1 ----------------------------------------------MERKVIELDQGWDYMQKGITKLKK     24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      1 ---------------------------------------MSVDSGSQFRPLIELDQGWEYISSMFAKLKR     31</a:t>
            </a:r>
          </a:p>
          <a:p>
            <a:r>
              <a:rPr lang="en-US" altLang="ja-JP" sz="800" dirty="0">
                <a:latin typeface="Courier"/>
                <a:cs typeface="Courier"/>
              </a:rPr>
              <a:t>PbCUL1           1 -------------------------------------------MAIHERKTIDLEQGWEFMQKGITKLKN     27</a:t>
            </a:r>
          </a:p>
          <a:p>
            <a:r>
              <a:rPr lang="en-US" altLang="ja-JP" sz="800" dirty="0">
                <a:latin typeface="Courier"/>
                <a:cs typeface="Courier"/>
              </a:rPr>
              <a:t>PavCUL1A         1 ----------------------------------------------MERKIIELDQGWDYMQKGITKLKK     24</a:t>
            </a:r>
          </a:p>
          <a:p>
            <a:r>
              <a:rPr lang="en-US" altLang="ja-JP" sz="800" dirty="0">
                <a:latin typeface="Courier"/>
                <a:cs typeface="Courier"/>
              </a:rPr>
              <a:t>PavCUL1B         1 -------------------------------------------MTMNERKTIDLEQGWEFMQKGITKLKN     27</a:t>
            </a:r>
          </a:p>
          <a:p>
            <a:r>
              <a:rPr lang="en-US" altLang="ja-JP" sz="800" dirty="0">
                <a:latin typeface="Courier"/>
                <a:cs typeface="Courier"/>
              </a:rPr>
              <a:t>PiCUL1G          1 -------------------------------------------MTIKQMNNIELQDGWAFMQKGVTKLKK     27</a:t>
            </a:r>
          </a:p>
          <a:p>
            <a:r>
              <a:rPr lang="en-US" altLang="ja-JP" sz="800" dirty="0">
                <a:latin typeface="Courier"/>
                <a:cs typeface="Courier"/>
              </a:rPr>
              <a:t>PiCUL1C          1 ---------------------------------------------MNQRSTIDLDQGWEFMQRGITKLKN     25</a:t>
            </a:r>
          </a:p>
          <a:p>
            <a:r>
              <a:rPr lang="en-US" altLang="ja-JP" sz="800" dirty="0">
                <a:latin typeface="Courier"/>
                <a:cs typeface="Courier"/>
              </a:rPr>
              <a:t>PhCUL1           1 -------------------------------------------MTIKQMNNIELQDGWAFMQKGVTKLKK     27</a:t>
            </a:r>
          </a:p>
          <a:p>
            <a:r>
              <a:rPr lang="en-US" altLang="ja-JP" sz="800" dirty="0">
                <a:latin typeface="Courier"/>
                <a:cs typeface="Courier"/>
              </a:rPr>
              <a:t>SpCUL1           1 -------------------------------------------MEETEEKTIELEEGMECVQKGLNKLKI     27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1           1 ----------------------------------------------MERKTIDLEQGWDYMQTGITKLKR     24</a:t>
            </a:r>
          </a:p>
          <a:p>
            <a:r>
              <a:rPr lang="en-US" altLang="ja-JP" sz="800" dirty="0">
                <a:latin typeface="Courier"/>
                <a:cs typeface="Courier"/>
              </a:rPr>
              <a:t>AtCUL2           1 ----------------------------------------------MAKKDSVLEAGWSVMEAGVAKLQK     24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  1 --------------------------------------MSN---QKKRNFQIEAFKHRVVVDPKYADKTW     2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  1 --------------------------------------MSN---QKKRNFQIEAFKQRVVVDPKYADKTW     2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 53 -------------------------EDPTPAAANLSRKKATLPQP-TKKFVIKLNKAKPTLPTNFEENTW     96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1-like      1 -------------------------------------------MATHERKTIDLEQGWEFMQKGITKLKN     27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  1 --------------------------------------MSGGGPPKKRNFKIELFKHRVELDPKYAERTW     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 71 GGRTNGEEDAEMVLADQEELAAPSASAPAGVAANLFRKKATLPQPSAARKPLRIKIGQPKLPTNFEEDTW    1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  1 -------------------------------------------MSETLPRSDDLEATWNFIEPGINQILG     27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                                                   . .  ..  .. .  ... 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 25 ILEGLPEP------QFNSEEYMMLYTTIYNMCTQKPPN-----------DYSQQLYDKYREAFEEYITST     77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 32 ILEGLPEP------QFSSVEYMTLYTTVYNMCTQKPPH-----------NYSQQLYDKYRAALEDYVTTT     8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 28 ILEGLPEP------QFSSEDYMMLYTTIYNMCTQKPPH-----------DYSQQLYDKYRESFEEYITST     8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 25 ILEGIPEP------QFNSEEYMMLYTTIYNMCTQKPPN-----------DYSQQLYDKYREAFEEYITST     7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 28 ILEGLPEP------QFSSEDYMMLYTTIYNMCTQKPPH-----------DYSQQLYDKYKESFEEYITST     8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 28 ILEGSSE-------SFSSEEYMMLYTTIYDMCTQKPPH-----------DHSQQLYDKYKGAFEEYINST     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 26 ILEGLPEP------QFSSEDYMMLYTTIYNMCTQKPPH-----------DYSQQLYDKYREAFEEYITAT     7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 28 ILEGSSE-------SFSSEEYMMLYTTIYDMCTQKPPH-----------DYSQQLYDKYKGAFEEYINST     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 28 IIEGEPE-------SFTSDEYVMLYTTIYNMCTQKAPH-----------DYSQQLYDKYKEAVEDYILTI     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 25 ILEGLNEP------AFDSEQYMMLYTTIYNMCTQKPPH-----------DYSQQLYDKYREAFEEYINST     77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 25 ILEEVPDEP-----PFDPVQRMQLYTTVHNLCTQKPPN-----------DYSQQIYDRYGGVYVDYNKQT     78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 30 QILERAIHQ-----IYNQDASGLSFEELYRNAYNMVLH-----------KFGEKLYTGFIATMTSHLKEK     83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 30 KILEHAIHE-----IYNHNASGLSFEELYRNAYNMVLH-----------KYGDKLYTGLVTTMTFHLKEI     83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 97 EKLQSAIRA-----IFLKKKISFDLESLYQAVDNLCLH-----------KLDGKLYDQIEKECEEHISAA    150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 28 ILEGKPEP------QFSSEDYMMLYTTIYNMCTQKPPH-----------DYSQQLYEKYRESFEEYITSM     80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 33 KVLEHAIHE-----IYNHNASGLSFEELYRSAYNMVLH-----------KYGEKLYDGLERTMTWRLKEI     86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141 AILKDAITA-----IFLKQKLSCDVEKLYQAAGDLCLH-----------KLGANLYERIKKECEVHISAK    194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 28 NEKNQASTSKRVYKILSPTMYMEVYTAIYNYCVNKSRSSGHFSTDSRTGQSTILVGSEIYEKLKNYLKNY     97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....  .        . .  ..................           ..........    ....  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 78 VLPALREKHD-EFMLRELVKRWANHKLMVRWLSRFFHYLDRYFIAR------RSLPALKEVGLTCFRDLV    1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 85 VLPSVNEKHG-ELMLQELVKRWTNYKIMIRWLSNCFNFLDRFFIPR------RSLPSLNDVGITCFRDSV    14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 81 VLPSLREKHD-EFMLRELVKRWTNHKIMVRWLSRFFHYLDRYFIAR------RSLPPLNEVGLTCFRDLV    14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 78 VLPSLREKHD-EFMLRELVKRWANHKVMVRWLSRFFHYLDRYFIAR------RSLPALNEVGLTCFRDLV    1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 81 VLPSLREKHD-EFMLRELVKRWTNHKIMVRWLSRFFHYLDRYFIAR------RSLPPLNEVGLTCFRDLV    14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 80 VLSSIREKHD-EFMLREFVKRWLNHKIMVRWLSRFFNYLDRYFIAR------RTLPALKEVGLMCFRDLV    14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 79 VLPSLREKHD-EFMLRELVKRWSNHKIMVRWLSRFFHYLDRYFIAR------RSLPGLNEVGLTCFRDQV    14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 80 VLSSIREKHD-EFMLREFVKRWLNHKIMVRWLSRFFNYLDRYFIAR------RSLPALKEVGLMCFRDLV    142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 80 VLPSLNKKHD-EFLLKELEKRWASHKLMVKWLLKFFRYLDKFFIKR------AEVPALNEVGLSCFRDLV    14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 78 VLPALREKHD-EFMLRELFKRWSNHKVMVRWLSRFFYYLDRYFIAR------RSLPPLNEVGLTCFRDLV    1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 79 VLPAIREKHG-EYMLRELVKRWANQKILVRWLSHFFEYLDRFYTRR------GSHPTLSAVGFISFRDLV    14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 84 SKLIEAAQG--GSFLEELNKKWNEHNKALEMIRDILMYMDRTYIES------TKKTHVHPMGLNLWRDNV    14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 84 CKSIEEAQG--GAFLELLNRKWNDHNKALQMIRDILMYMDRTYVST------TKKTHVHELGLHLWRDNV    14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151 LQSLVGQNTDLTVFLSRVEKCWQDFCDQMLMIRSIALTLDRKYVIQN-----PNVRSLWEMGLQLFRKHL    215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 81 VLPSLREKHD-EFMLRELVKRWSNHKVMVRWLSRFFHYLDRYFISR------RSLPQLSEVGLSCFRDLV    143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 87 SKSIEAAQG--GLFLEELNAKWMDHNKALQMIRDILMYMDRTYVPQ------SRRTPVHELGLNLWRDHI    148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195 ISALVGQSPDLVVFLSLVQRTWQDFCDQMLIIRGIALLLDVKYVKNV-----ANICSVWDMGLKLFRKHL    259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 98 ILNFKQSNSE--TFLQFYVKRWKRFTIGAIFLNHAFDYMNRYWVQKERSDGKRHIFDVNTLCLMTWKEVM    165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...  ..... ...*......* ... ...... .. ....... .      .... . .... ......</a:t>
            </a:r>
          </a:p>
          <a:p>
            <a:endParaRPr kumimoji="1" lang="ja-JP" altLang="en-US" sz="800" dirty="0">
              <a:latin typeface="Courier"/>
              <a:cs typeface="Courier"/>
            </a:endParaRPr>
          </a:p>
        </p:txBody>
      </p:sp>
    </p:spTree>
    <p:extLst>
      <p:ext uri="{BB962C8B-B14F-4D97-AF65-F5344CB8AC3E}">
        <p14:creationId xmlns:p14="http://schemas.microsoft.com/office/powerpoint/2010/main" val="1171872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81531" y="17134"/>
            <a:ext cx="6094938" cy="10064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141 YR--EVNANARIAVIGLIDKEREGEQIDRALLKNVVDIFVEIGMGQ-------MESYEEDFEAHFLLDSG    201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148 YR--KVQVNARVTVIGLIDSERVGEQIDRALVKNVIDLFVGIGMGR-------MDAYEEDFEAHMLRHAG    20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144 YQ--ELKPKVRGAVISLIDQEREGEQIDRALLKNVLDIFVEIGMGQ-------MGHYENDFETDMLKDTA    20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141 YR--EVNANARVAVIGLIDKEREGEQIDRALLKNVIDIFVEIGMGN-------MDAYEGDFEAYMLGDSG    20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144 YQ--ELNAKVRDAVISLIDQEREGEQIDRALLKNVLDIFVEIGMGH-------MDHYENDFEADMLKDTA    20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143 YQ--ELKVKGRDAVIALIDLEREGEQIDRALLKNVLDIFVEIGMGQ-------MDYYENDFEDAMLKDTA    20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142 YQ--ELNGKVRDAVISLIDQEREGEQIDRALLKNVLDIFVEIGMGQ-------MDQYENDFEASMLKDTA    20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143 YQ--ELKVKGRDAVIALIDLEREGEQIDRALLKNVLDIFVEIGMGQ-------MDYYENDFEDAMLKDTA    203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143 YH--DVKNRVTDAVIALIDQEREGEKIDRVLLKNVINLYIDMGKGR-------MDYYVNDFEEAMLRDSA    203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141 YN--ELHSKVKQAVIALVDKEREGEQIDRALLKNVLDIYVEIGMGQ-------MERYEEDFESFMLQDTS    20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142 YQ--ELQSKAKDAVLALIHKEREGEQIDRALLKNVIDVYCGNGMGE-------LVKYEEDFESFLLEDSA    20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146 VHFTKIHTRLLNTLLDLVQKERIGEVIDRGLMRNVIKMFMDLGES----------VYQEDFEKPFLDASS    20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146 VYSSKIQTRLLNTLLDLVHKERTGEVIDRVLMRNVIKMFMDLGES----------VYQDDFEKPFLEASA    20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216 SLAPEVEQRTVKGLLSMIEKERLAEAVNRTLLSHLLKMFTALG------------IYMESFEKPFLEGTS    273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144 YQ--EIKGKVKSAVISLIDQEREGEQIDRALLKNVLDIFVEIGLTS-------MDYYENDFEDFLLKDTA    204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149 IHSPMIHSRLLDTLLDLIHRERMGEMINRGLMRSITKMLMDLGAA----------VYQDDFEKPFLDVTA    208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260 SLSPEIEHKTVTGLLRLIESERLGEAIDRTLLSHLLKMFTALG------------MYSESFEKPFLECTS    317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166 FD--PSKDVLINELLDQVTLGREGQIIQRSNISTAIKSLVALGIDPQDLKKLNLNVYIQVFEKPFLKKTQ    233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.   .       ... ... .*......*...... . .. .*..        .  *. .**   * ..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202 EYYSRKAANWILTDSCPEYMLKAEECLKREKERVNNYLHSSSEQKLVEKVQHELLVVYATQLLEKEGSGC    271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209 EYYSRKAASWLLEDFCPDFLVKAEECLRRERDRVSHYLHSSSELKLVEKVQHELF---------------    26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205 AYYSRKASNWILEDSCPDYMLKAEECLKREKDRVSNYLHSSSEPKLLEKVQHELLSVYATQLLEKEHSGC    27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202 EYYSRKASNWILEDSCPDYMLKAEECLKREKERVSHYLHSSSEQKLVEKVQHELLVVYATQLLDKEHSGC    27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205 AYYSRKASNWILEDSCPDYMLKAEECLRREKDRVAHYLHSSSEPKLLEKVQHELLSVYATQLLEKEHSGC    27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204 AFYSRKASNWIMEDSCPDYMLKAEECLKKEKDRVSHYLHSSSEEKLLEKVQNELLVVHTNQLLEKENSGC    27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203 AYYSRKASNWILEDSCPDYMLKAEECLKREKDRVAHYLHSSSETKLLEKVQHELLSVYATQLLEKEHSGC    27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204 AFYSRKASNWIMEGSCPDYMLKAEECLKKEKDRVSHYLHSSSEEKLLEKVQNELLVVHTNQLLEKENSGC    273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204 CHYSRKASTWIVEDSCPEYMLKAEECLQKEKDRVSHYLHSSTETKLLEKMQNQVLITYTNQLLEKEDSGC    273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202 SYYSRKASSWIQEDSCPDYMLKSEECLKKERERVAHYLHSSSEPKLVEKVQHELLVVFASQLLEKEHSGC    27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203 SYYSRNASRWNQENSCPDYMIKAEESLRLEKERVTNYLHSTTEPKLVAKVQNELLVVVAKQLIENEHSGC    27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206 EFYKVESQEFIESCDCGDYLKKSEKRLTEEIERVAHYLDAKSEEKITSVVEKEMIANHMQRLVHMENSGL    27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206 EFYKVESMEFIESCDCGEYLKKAEKPLVEEVERVVNYLDAKSEAKITSVVEREMIANHVQRLVHMENSGL    27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274 EFYAAEGMKYMQQSDVPEYLKHVEGRLHEENERCILYIDAVTRKPLITTVERQLLERHILVVLEK---GF    3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205 DYYSIKAQTWILEDSCPDYMLKAEECLKREKERVAHYLHSSSEQKLLEKVQHELLTQYASQLLEKEHSGC    274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209 SFYSGESQEFIECCDCGNYLKKSERRLNEEMERVSHYLDSGTEAKITSVVEKEMIANHMHRLVHMENSGL    278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318 EFYATEGVKYLQQSDIPDYLKHVETRLQEEHERCILYLEANTRKPLITATEKQLLQRHTSAILEK---GF    384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234 EYYTQYTNDYLEKHSVTEYIFEAHEIIKREEKAMTIYWDDHTKKPLSMALNKVLITDHIEKLEN----EF    299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 .*....  .. ...............  *.... .*...... .. .... ...     ...... ..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272 RALLRLDKADGLSRIFRLYNKIPKGLDPVSLVFKQHITAEGTALVQQ----------AEDAAANQASGG-    330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264 --------------------------EPLAEILKQKVSFEVKSLVQQ----------AEYTASNETSDRS    29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275 HALLRDDKVDDLSRMFRLFSKIPRGLDPVSQIFKQHVTAEGTALVKQ----------AEDAASNKKAEKK    33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272 RALLRDDKVEDLSRIYRLYNKIPKGLEPVSSVFKQHVTAEGTALVQQ----------AEDVASNQASSG-    33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275 HALLRDDKVDDLSRMFRLFSKIPRGLDPVSSIFKQHVTAEGTALVKQ----------AEDAASNKKAEKK    33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274 RVLLRDDKVVDLSRMYRLFHRIPKGLEPVAKMFKQHVTAEGMVLVQQ----------AEDSASNKAGIS-    3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273 HALLRDDKVEDLSRMYRLFSKILRGLDPVANIFKQHVTAEGTALVKQ----------AEDAASNKKAEKR    3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274 RVLLRDDKVVDLSRMYRLFHRIPKGLEPVAKMFKQHVTAEGMVLVQQ----------AEDSASNKAGIS-    3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274 RALLKDEKVEDLTRMYSLFHKFPKGIELVAEIFKQHVAAEGMVVVQQ----------AADVANNKTESS-    3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272 RALLRDDKVDDLSRMYRLYHKILRGLEPVANIFKQHVTAEGNALVQQ----------AEDTATNQVANT-    33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273 RALLRDDKMDDLARMYRLYHPIPQGLDPVADLFKQHITVEGSALIKQ----------ATEAATDKAASTS    3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276 VNMLLNDKYEDLGRMYNLFRRVTNGLVTVRDVMTSHLREMGKQLVTD----------PEKSKDP------    32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276 VNMLLNDKYEDMGRMYSLFRRVANGLVTVRDVMTLHLREMGKQLVTD----------PEKSKDP------    32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341 TTLMDGRRTEDLQRMQTLFSRVN-ALESLRQALSSYVRKTGQKIVMD----------EEKDKD-------    392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275 HALLRDDKVDDLSRMYRLFSRITRGLEPVSQIFKQHVTNEGTALVKQ----------AEDAASNKKPEKK    334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279 VNMLVDDKYDDLARMYNLFRRVFDGLSTIRDVMTSYLRETGKQLVTD----------PERLKDP------    3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385 TMLMEANRVKDLSRMYTLFQRVD-AIELLKQALSSYIRGTGQGIIMD----------EEKDKE-------    436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300 VVLLDARDIEKITSLYALIRRDFTLIPRMASVFENYVKKTGENEISSLLAMHKHNIMKNENANPKKLALM    369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  ....... .........  .  .. ..   ...... ..  .. .          ... . .      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331 --AGTQEQALIKNIIELHDKYMKYVDESFQNHTLFHKALKEAFEVFCNKSVS----------GSSSAELL    388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298 --SGMLEQVLVTNIIELHDKHMAYFNDCSIKNHVFHKALREAFDVFCNKAVS----------GYSSAQLL    355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335 DVVGLQEQVFVRKVIELHDKYIAYVNECFQNHTLFHKALKEAFEIFCNKGVA----------GSSSAELL    39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331 --AGTQEQVLVRKIIELHDKYMAYVTDCFLNHTLFHKALKEAFEVFCNKAVS----------GSSSAELL    38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335 DVVGLQEQVFVRKVIELHDKYLAYVNDCFQNHTLFHKALKEAFEIFCNKGVA----------GSSSAELL    39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333 --SGSQEQVFIRKVIELHDKYMAYVIDCFANNSLFHKALKEAFEVFCNKTVA----------GSSSAELL    39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333 DVVGLQEQVFVRKVIELHDKYLAYVNNCFQNHTLFHKALKEAFEVFCNKGVA----------GSSSAELL    39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333 --SGSQEQVFIRKIIELHDKYMAYVIDCFANNSLFHKALKEAFEVFCNKTVA----------GSSSAELL    390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333 --GVSHEQDFVKKAFELHDKYMVYVKGCFADNSIFHKALKEAFEVFCNKSVA----------GSSTAELL    39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331 --ASVQEQVLIRKVIELHDKYMVYVTECFQNHTLFHKALKEAFEIFCNKTVA----------GSSSAELL    388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333 G-LKVQDQVLIRQLIDLHDKFMVYVDECFQKHSLFHKALKEAFEVFCNKTVA----------GVSSAEIL    39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330 -------VEFVQRLLDERDKYDKIINTAFGNDKTFQNALNSSFEYFINLN-------------ARSPEFI    3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330 -------VEFVQRLLDERDKYDRIINMAFNNDKTFQNALNSSFEYFVNLN-------------TRSPEFI    3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393 ---------MVQSLLDFKASLDIIWEESFYKNESFGNTIKDSFEHLINLRQ------------NRPAELI    441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335 EIVGLQEQVFVRKIIELHDKYVAYVTDCFQGHTLFHKALKEAFEVFCNKGVS----------GSSSAELL    394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333 -------VEFVQRLLNEKDKHDKIINVAFGNDKTFQNALNSSFEYFINLN-------------NRSPEFI    382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437 ---------LVPFLLEFKASLDRILEESFAKNEAFSNTIKESFEHLINLRQ------------NRPAELI    485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370 TAHSLSPKDYIKKLLEVHDIFSKIFNESFPDDIPLAKALDNACGAFININEFALPAGSPKSATSKTSEML    439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     ...... . .......  ..  .. .  ........... ..*. .           .......</a:t>
            </a:r>
            <a:r>
              <a:rPr lang="pl-PL" altLang="ja-JP" sz="800" dirty="0" smtClean="0">
                <a:latin typeface="Courier"/>
                <a:cs typeface="Courier"/>
              </a:rPr>
              <a:t>.</a:t>
            </a:r>
            <a:endParaRPr lang="pl-PL" altLang="ja-JP" sz="800" dirty="0">
              <a:latin typeface="Courier"/>
              <a:cs typeface="Courier"/>
            </a:endParaRPr>
          </a:p>
        </p:txBody>
      </p:sp>
    </p:spTree>
    <p:extLst>
      <p:ext uri="{BB962C8B-B14F-4D97-AF65-F5344CB8AC3E}">
        <p14:creationId xmlns:p14="http://schemas.microsoft.com/office/powerpoint/2010/main" val="4774545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81531" y="34322"/>
            <a:ext cx="6094938" cy="99411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altLang="ja-JP" sz="800" dirty="0">
                <a:latin typeface="Courier"/>
                <a:cs typeface="Courier"/>
              </a:rPr>
              <a:t>MdCUL1A        389 AGFCDNILKKGG-SDKLSDEAIEEMLEKVVKLLAYISDKDLYAEFYRKKLARRLLFDRSANEDHERSILT    457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356 ATFCENILKKGG-SQKLSDEAIEVMLDKVVKFLTYISDKDLFAEFYRKKLARRLLFDPSADKEHEKSILT    42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395 ATFCDNILKKGG-SEKLSDEAIEETLEKVVKLLAYISDKDLFAEFYRKKLARRLLFDKSANDDHERCILT    46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389 AGFCDNILKKGG-SEKLSDEAIEETLEKVVKLLAYISDKDLFAEFYRKKLARRLLFDRSANEDHEKSILT    45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395 ATFCDNILKKGG-SEKLSDEAIEETLEKVVKLLAYISDKDLFAEFYRKKLARRLLFDKSANDDHERCILT    46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391 ASYCDNILKKGG-SEKLSDDAIEETLDKVVKLLAYISDKDLFAEFYRKKLSRRLLFDKSGNDDHERLILT    459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393 ATFCDNILKKGG-SEKLSDEAIEDTLEKVVKLLAYISDKDLFAEFYRKKLAGGCYLIKSANDEHERSILT    46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391 ASYCDNILKKGG-SEKLSDDAIEETLDKVVKLLAYISDKDLFAEFYRKKLSRRLLFDKSGNDDHERLILT    459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391 ASYCDNTLKKGG-SEQLSDDVIEDTLEKVVKLVTYISDKDVFAEFYRKKLSRRLLFDRSANEEHERLILS    45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389 ATFCDNILKKGG-SEKLSDEAIEDTLEKVVKLLAYISDKDLFAEFYRKKLARRLLFDRSANDDHERSILT    457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392 ATYCDNILKTGGGIEKLENEDLELTLEKVVKLLVYISDKDLFAEFFRKKQARRLLFDRNGNDYHERSLLT    46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380 SLFVDDKLRKGL--KGITDVDVEVILDKVMMLFRYLQEKDVFEKYYKQHLAKRLLSGKTVSDDAERSLIV    447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380 SLFVDDKLRKGL--KGVGEEDVDLILDKVMMLFRYLQEKDVFEKYYKQHLAKRLLSGKTVSDDAERNLIV    447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442 AKFLDEKLRAGN--KGTSEEELESVLEKVLVLFRFIQGKDVFEAFYKKDLAKRLLLGKSASIDAEKSMIS    509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395 ATFCDNILKKGG-SEKLSDEAIEDTLEKVVRLLAYISDKDLFAEFYRKKLARRLLFDKSANDEHERSILT    463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383 SLYVDDKLRKGL--KGATEEDVEVILDKVMMLFRYLQEKDVFEKYYKQHLAKRLLSGKTVSDDAERSMIV    450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486 AKFLDEKLRAGN--KGTSEEELEGILDKVLVLFRFIQGKDVFEAFYKKDLAKRLLLGKSASIDAEKSMIT    553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440 AKYSDILLKKAT----KPEVASDMSDEDIITIFKYLTDKDAFETHYRRLFAKRLIHGTSTSAEDEENIIQ    505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. .....*.... .......... ......... ....**........................*....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458 KLKQQCGGQFTSKMEGMVTDLTIARDNQKGFEEYLQSNPAVNPG--MDLTVTVLTTGYWP-SYKSFDLNL    524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425 KMKQQCGGQFTSKMEGMVTDLTLARENQTSFEEYLCNSPNVDPG--IDFTITVLTTGFWP-SYKTCDLSL    49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464 KLKQQCGGQFTSKMDGMVTDLTLAKDNQVGFEEYLRNNPQANPG--IDLTVTVLTTGFWP-SYKTFDLNL    53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458 KLKQQCGGQFTSKMEGMVTDLTLARDNQANFEEYLHNYPDVNPG--MDLTVTVLTTGYWP-SYKSFDLNL    52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464 KLKQQCGGQFTSKMEGMVTDLTLAKENQASFEDYLSKNPQANPG--IDLTVTVLTTGFWP-SYKSFDLNL    53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460 KLKQQCGGQFTSKMEGMVTDLTLAKENQNHFQEYLSNNPAASPG--IDLTVTVLTTGFWP-SYKSSDLRL    526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462 KLKQQCGGQFTSKMEGMVTDLTLARENQASFEEYLSNNPAANPG--IDLTVTVLTTGFWP-SYKSFDLQP    52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460 KLKQQCGGQFTSKMEGMVTDLTLAKENQNHFQEYLSNNPAASPG--IDLTVTVLTTGFWP-SYKSSDLRL    526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460 KLKQQCGGQFTSKMEGMVTDLSLVKDNQTHFQEYISNNPATNPG--IDMTVTVLTTGFWP-SYKSCDLNL    526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458 KLKQQCGGQFTSKMEGMVTDLTLARENQNSFEDYLGSNPAANPG--IDLTVTVLTTGFWP-SYKSFDINL    524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462 KFKELLGAQFTSKMEGMLTDMTLAKEHQTNFVEFLSVNKTKKLG--MDFTVTVLTTGFWP-SYKTTDLNL    528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448 KLKTECGYQFTSKLEGMFTDMKTSEDTMRGFYGSHP---ELSEG--PTLIVQVLTTGSWP-TQPAVPCNL    51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448 KLKTECGYQFTSKLEGMFTDMKTSHDTLLGFYNSHP---ELSEG--PTLVVQVLTTGSWP-TQPTIQCNL    51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510 KLKTECGSQFTNKLEGMFKDIELSKEINESFKQSSQARTKLPSG--IEMSVHVLTTGYWP-TYPPMDVKL    576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464 KLKQQCGGQFTSKMEGMVTDLTVARDHQAKFEEFISTHSELNPG--IALAVTVLTTGFWP-SYKSFDINL    530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451 KLKTECGYQFTSKLEGMFTDMKTSQDTMIDFYAKKSE--ELGDG--PTLDVHILTTGSWP-TQPCPPCNL    515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554 KLKTECGSQFTNKLEGMFKDIELSKEINESFKQSSQARTKLPSG--IEMSVHVLTTGYWP-TYPPMDVKL    620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506 RLQAANSMEYTGKITKMFQDIRLSKILEDDFAVALKNEPDYSKAKYPDLQPFVLAENMWPFSYQEVEFKL    575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..........*.*...*..*....  ..  * ...   .   ..  .......*....** ...  ...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525 PEEMVRCVEVFKSFYETKTKHRKLTWIYSLGTCNVTGKFDTR---PIELVVSTYQAALLLLFNSADKLSY    591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492 PAEMVKCVEVFKGFYERKTKCRKITWIYSLGTCNIIGKFELK---EIELVVSTYQGALLLLFNSMDRLSY    55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531 PPEMVKCVELFREFYQTKTKHRKLTWMYSLGTCNIIGKFEPK---TIELIVTTYQASALLLFNTSDRLSY    59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525 PEEMVKCVEVFKGFYETKTKHRKLTWIYSLGTCNVNGKFEPK---NIELVVSTYQAALLLLFNTADKLSY    59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531 PAEMVKCVEIFREFYQTKTKHRKLTWMYSLGTCNISGKFEPK---TIELIVTTYQASALLLFNTSDRLSY    59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527 PMEMVKCVEVFKEFYQTKTKHRKLTWIYSLGTCHINGKFEPK---TIELVLGTYQAAVLLLFNASDRLSY    59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529 PTEMVRCVEVFKEFYQTKTKHRKLTWIYSLGTCNINGKFDPK---TIELVVTTYQASALLLFNASDRLSY    595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527 PMEMVKCVEVFKEFYQTKTKHRKLTWIYSLGTCHINGKFEPK---TIELVLGTYQAAVLLLFNASDRLSY    593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527 PVEMAKGVESFKEFYQKKTKHRKLTWIFSLGQCNLNGKFEQK---TIELILGTYQAAALLLFNASDKWSY    593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525 PSEMIKCVEVFKGFYETKTKHRKLTWIYSLGTCHINGKFDQK---AIELIVSTYQAAVLLLFNTTDKLSY    59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529 PIEMVNCVEAFKAYYGTKTNSRRLSWIYSLGTCQLAGKFDKK---TIEIVVTTYQAAVLLLFNNTERLSY    59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512 PAEVSVLCEKFRSYYLGTHTGRRLSWQTNMGTADIKAIFGKGQ--KHELNVSTFQMCVLMLFNNSDRLSY    5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512 PAEVSVLCEKFRSYYLGTHTGRRLSWQTNMGTADIKAVFGKGQ--KHELNVSTFQMCVLMLFNNSDRLSY    579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577 PHELNVYQDIFKEFYLSKYSGRRLMWQNSLGHCVLKADFSKG---KKELAVSLFQAVVLMLFNDAMKLSF    643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531 PAEMVKCVEVFKEFYQTRTKHRKLTWIYSLGTCNINAKFEAK---TIELIVTTYQAALLLLFNGVDRLSY    597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516 PTEILAICDKFRTYYLGTHSGRRLTWQTNMGTADIKATFGKGQ--KHELNVSTYQMCVLMLFNSTDGLTY    583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621 PHELNVYQDIFKEFYLSKYSGRRLMWQNSLGHCVLKAEFPKG---KKELAVSLFQSVVLMLFNDAQKLSF    687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576 PKELVPSHEKLKESYSQKHNGRILKWLWPLCRGELKADIGKPGRMPFNFTVTLFQMAILLLYNDADVLTL    645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* *.. ... ....* .....*...*....... . ...  .    ... . ..*.. *.*.*  ....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592 SEILTQLNLTHDDLVRLLHSLSCAKYK-ILTKQPITKTISTNDSFEFNKKFTDKMRRIKIP---------    651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559 SEILSKLNLTHEAAIRVLHSLSCAKYK-ILIKEPDTKTISPNDSFEFNYKFTDRMRRIKIP---------    61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598 SEIMTQLNLTDDDVVRLLHSLSCAKYK-ILNKEPNTKTISPTDYFEFNAKFTDKMRRIKIP---------    65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592 SEILTQLNLTHDDLVRLLHSLSCAKYK-ILLKEPNTKTISPTDSFEFNSKFTDRMRRIKIP---------    651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598 SEIMTQLNLTDDDVVRLLHSLSCAKYK-ILNKEPNTKTLSPTDYFEFNSKFTDKMRRIKIP---------    657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594 SDIKSQLNLADDDLVRLLQSLSCAKYK-ILTKDPSNRTVSSTDHFEFNSKFTDKMRRIRVP---------    65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596 QEIMAQLNLSDDDVVRLLHSLSCAKYK-ILNKEPSTKTISQTDVFEFNSKFTDKMRRIKIP---------    655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594 SDIKSQLNLADDDLVRLLQSLSCAKYK-ILTKDPSNRTVSSTDHFEFNSKFTDKMRRIRVP---------    653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594 ADIKTELNLADDDLVRVLASVSCAKYK-ILNKEPSGRTVSSTDHFEFNSQFTDKMRRIRVP---------    653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592 TEILAQLNLSHEDLVRLLHSLSCAKYK-ILLKEPNTKTVSQNDAFEFNSKFTDRMRRIKIP---------    65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596 TEILEQLNLGHEDLARLLHSLSCLKYK-ILIKEPMSRNISNTDTFEFNSKFTDKMRRIRVP---------    655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580 KEIEQATEIPAADLKRCLQSLACVKGKNVIKKEPMSKDIGEEDLFVVNDKFTSKFYKVKIGT--------    64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580 KEIEQATEIPTPDLKRCLQSMACVKGKNVLRKEPMSKEIAEEDWFVVNDRFASKFYKVKIGT--------    641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644 EDIKDSTSIEDKELRRTLQSLACGKVR-VLQKNPKGRDVEDGDEFEFNDEFAAPLYRIKVN---------    703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598 SEIVTQLNLSDDDVVRLLHSLSCAKYK-ILSKEPNNRSISPNDVFEFNSKFTDKLRRLKIP---------    657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584 KDIEQDTAIPASDLKRCLQSLACVKGKNVLRKEPMSKDISEDDTFYFNDKFTSKLVKVKIGT--------    645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688 LDIKESTGIEDKELRRTLQSLACGKVR-VLQKMPKGRDVEDKDEFVFNEEFSAPLYRIKVN---------    747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646 ENIQEGTSLTIQHIAAAMVPFIKFKLIQQVPPG-LDALVKPETQFKLSRPYKALKTNINFASGVKNDILQ    714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 .*  ....   ...... .....*.. .. ...  ....  . *... ............         </a:t>
            </a:r>
          </a:p>
        </p:txBody>
      </p:sp>
    </p:spTree>
    <p:extLst>
      <p:ext uri="{BB962C8B-B14F-4D97-AF65-F5344CB8AC3E}">
        <p14:creationId xmlns:p14="http://schemas.microsoft.com/office/powerpoint/2010/main" val="1857572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81531" y="531477"/>
            <a:ext cx="6094938" cy="5262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altLang="ja-JP" sz="800" dirty="0">
                <a:latin typeface="Courier"/>
                <a:cs typeface="Courier"/>
              </a:rPr>
              <a:t>MdCUL1A        652 ---------------LPPVDERKKVIEDVDKDRRYAIDAAIVRIMKSRKVLGHQQLVMECVEQLGKMFKP    706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619 ---------------LPPVEERKEVIQDVEKERRYAIDAAIVRIMKSRKVLEHQQLVTECVEQLRHKFKP    673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658 ---------------LPPVDEKKKVIEDVDKDRRYAIDASIVRIMKSRKVLGHQQLVMECVEQLGRMFKP    71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652 ---------------LPPVDERKKVIEDVDKDRRYAIDAAIVRIMKSRKVLGHQQLVMECVEQLGRMFKP    706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658 ---------------LPPVDEKKKVIEDVDKDRRYAIDASIVRIMKSRKVLGHQQLVMECVEQLGRMFKP    71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654 ---------------LPPVDERKKVVEDVDKDRRYAMDACIVRIMKSRKVLPHQQLVLECVEQLSRLFKP    70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656 ---------------LPPVDEKKKVIEDVDKDRRYAIDASIVRIMKSRKVLGYQELVMECVEQLGRMFKP    71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654 ---------------LPPVDERKKVVEDVDKDRRYAMDACIVRIMKSRKVLPHQQLVLECVEQLSRLFKP    708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654 ---------------LPPVDDRKKMVEEVGKDRRYAIDACLVRIMKAKKVLTHQQLILECVEQLSKMFKP    708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652 ---------------LPPVDERKKVVEDVDKDRRYAIDAAIVRIMKSRKVLGHQQLVSECVEQLSRMFKP    706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656 ---------------LPPMDERKKIVEDVDKDRRYAIDAALVRIMKSRKVLGHQQLVSECVEHLSKMFKP    71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642 -----------VVAQKETEPEKQETRQRVEEDRKPQIEAAIVRIMKSRKILDHNNIIAEVTKQLQPRFLA    70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642 -----------VVAQKETEPEKQETRQRVEEDRKPQIEAAIVRIMKSRRVLDHNNIIAEVTKQLQTRFLA    70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704 -----------AIQMKETVEENTSTTERVFQDRQYQIDAAIVRIMKTRKVLSHTLLITELFQQLK--FPI    760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1-like    658 ---------------LPPVDEKKKVVEDVDKDRRYAIDASIVRIMKSRKVLGHQQLVMECVEQLGRMFKP    712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3-like    646 -----------VVAQKESEPEKQETRQRVEEDRKPQIEAAIVRIMKSRRVLDHNSIVAEVTKQLQARFMP    704</a:t>
            </a:r>
          </a:p>
          <a:p>
            <a:r>
              <a:rPr lang="pl-PL" altLang="ja-JP" sz="800" dirty="0">
                <a:latin typeface="Courier"/>
                <a:cs typeface="Courier"/>
              </a:rPr>
              <a:t>OsCUL4-like    748 -----------AIQMKETVEENTSTTERVFQDRQYQVDAAIVRIMKTRKTLSHTLLITELFQQLK--FPI    804</a:t>
            </a:r>
          </a:p>
          <a:p>
            <a:r>
              <a:rPr lang="pl-PL" altLang="ja-JP" sz="800" dirty="0">
                <a:latin typeface="Courier"/>
                <a:cs typeface="Courier"/>
              </a:rPr>
              <a:t>ScCDC53        715 SLSGGGHDNHGNKLGNKRLTEDERIEKELNTERQIFLEACIVRIMKAKRNLPHTTLVNECIAQSHQRFNA    784</a:t>
            </a:r>
          </a:p>
          <a:p>
            <a:r>
              <a:rPr lang="pl-PL" altLang="ja-JP" sz="800" dirty="0">
                <a:latin typeface="Courier"/>
                <a:cs typeface="Courier"/>
              </a:rPr>
              <a:t>                                  ...... ... ......*.....*..*****....* ..... *.....   *..</a:t>
            </a:r>
          </a:p>
          <a:p>
            <a:endParaRPr lang="pl-PL" altLang="ja-JP" sz="800" dirty="0">
              <a:latin typeface="Courier"/>
              <a:cs typeface="Courier"/>
            </a:endParaRPr>
          </a:p>
          <a:p>
            <a:r>
              <a:rPr lang="pl-PL" altLang="ja-JP" sz="800" dirty="0">
                <a:latin typeface="Courier"/>
                <a:cs typeface="Courier"/>
              </a:rPr>
              <a:t>MdCUL1A        707 DIKAIKKRIEDLITRDYLERDKENPNMFKYLA                                          738</a:t>
            </a:r>
          </a:p>
          <a:p>
            <a:r>
              <a:rPr lang="pl-PL" altLang="ja-JP" sz="800" dirty="0">
                <a:latin typeface="Courier"/>
                <a:cs typeface="Courier"/>
              </a:rPr>
              <a:t>MdCUL1B        674 DIRAIKKQIEGLIIRDYLERDKEDRNLFKYLA                                          705</a:t>
            </a:r>
          </a:p>
          <a:p>
            <a:r>
              <a:rPr lang="pl-PL" altLang="ja-JP" sz="800" dirty="0">
                <a:latin typeface="Courier"/>
                <a:cs typeface="Courier"/>
              </a:rPr>
              <a:t>PbCUL1         713 DFKAIKKRIEDLITRDYLERDKDNPNLFRYLA                                          74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A       707 DIKAIKKRIEDLITRDYLERDKENPNMFKYLA                                          738</a:t>
            </a:r>
          </a:p>
          <a:p>
            <a:r>
              <a:rPr lang="pl-PL" altLang="ja-JP" sz="800" dirty="0">
                <a:latin typeface="Courier"/>
                <a:cs typeface="Courier"/>
              </a:rPr>
              <a:t>PavCUL1B       713 DFKAIKKRIEDLITRDYLERDKDNPNLFRYLA                                          744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G        709 DFKEIKKRIEDLITREYLERDQENPNVFKYLA                                          7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PiCUL1C        711 DVKAIKKRIEDLITRDYLERDKDNPNLFKYLA                                          742</a:t>
            </a:r>
          </a:p>
          <a:p>
            <a:r>
              <a:rPr lang="pl-PL" altLang="ja-JP" sz="800" dirty="0">
                <a:latin typeface="Courier"/>
                <a:cs typeface="Courier"/>
              </a:rPr>
              <a:t>PhCUL1         709 DFKEIKKRIEDLITREYLERDQENPNVFKYLA                                          7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SpCUL1         709 DVKAIKKRIEDLITRDYLERDLENTNTYKYIA                                          740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1         707 DIKAIKKRMEDLITRDYLERDKENPNMFRYLA                                          738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2         711 DIKMIKKRIEDLISRDYLERDTDNPNTFKYLA                                          74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A        701 NPTEIKKRIESLIERDFLERDSTDRKLYRYLA                                          7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3B        701 NPTEIKKRIESLIERDFLERDNTDRKLYRYLA                                          732</a:t>
            </a:r>
          </a:p>
          <a:p>
            <a:r>
              <a:rPr lang="pl-PL" altLang="ja-JP" sz="800" dirty="0">
                <a:latin typeface="Courier"/>
                <a:cs typeface="Courier"/>
              </a:rPr>
              <a:t>AtCUL4         761 KPADLKKRIESLIDREYLEREKSNPQIYNYLA                                          792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1-like    713 DFKAIKKRIEDLITRDYLERDKDNPNVYRYLA                                          744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3-like    705 NPVVIKKRIESLIEREFLERDKADRKLYRYLA                                          736</a:t>
            </a:r>
          </a:p>
          <a:p>
            <a:r>
              <a:rPr lang="en-US" altLang="ja-JP" sz="800" dirty="0">
                <a:latin typeface="Courier"/>
                <a:cs typeface="Courier"/>
              </a:rPr>
              <a:t>OsCUL4-like    805 KPSDIKKRIESLIDREYLERDRSNPQIYNYLA                                          836</a:t>
            </a:r>
          </a:p>
          <a:p>
            <a:r>
              <a:rPr lang="en-US" altLang="ja-JP" sz="800" dirty="0">
                <a:latin typeface="Courier"/>
                <a:cs typeface="Courier"/>
              </a:rPr>
              <a:t>ScCDC53        785 KVSMVKRAIDSLIQKGYLQRG-DDGESYAYLA                                          815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    . . .*.....**....*.*.. ... . *.*</a:t>
            </a:r>
          </a:p>
          <a:p>
            <a:endParaRPr lang="ja-JP" altLang="en-US" sz="800" dirty="0"/>
          </a:p>
          <a:p>
            <a:endParaRPr lang="ja-JP" altLang="en-US" sz="800" dirty="0"/>
          </a:p>
          <a:p>
            <a:endParaRPr kumimoji="1" lang="ja-JP" altLang="en-US" sz="800" dirty="0"/>
          </a:p>
        </p:txBody>
      </p:sp>
      <p:sp>
        <p:nvSpPr>
          <p:cNvPr id="7" name="正方形/長方形 6"/>
          <p:cNvSpPr/>
          <p:nvPr/>
        </p:nvSpPr>
        <p:spPr>
          <a:xfrm>
            <a:off x="3340100" y="561304"/>
            <a:ext cx="2667000" cy="2378746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1270000" y="2999704"/>
            <a:ext cx="1949450" cy="2378746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5956300" y="450850"/>
            <a:ext cx="101600" cy="2548854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/>
          <p:cNvSpPr/>
          <p:nvPr/>
        </p:nvSpPr>
        <p:spPr>
          <a:xfrm>
            <a:off x="1219200" y="2940050"/>
            <a:ext cx="101600" cy="2548854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406410" y="2890282"/>
            <a:ext cx="954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Times New Roman"/>
                <a:cs typeface="Times New Roman"/>
              </a:rPr>
              <a:t>NEDD8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2437671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1</TotalTime>
  <Words>5351</Words>
  <Application>Microsoft Macintosh PowerPoint</Application>
  <PresentationFormat>A4 210x297 mm</PresentationFormat>
  <Paragraphs>279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南川 舞</dc:creator>
  <cp:lastModifiedBy>南川 舞</cp:lastModifiedBy>
  <cp:revision>83</cp:revision>
  <cp:lastPrinted>2014-01-17T05:56:58Z</cp:lastPrinted>
  <dcterms:created xsi:type="dcterms:W3CDTF">2013-11-20T09:12:09Z</dcterms:created>
  <dcterms:modified xsi:type="dcterms:W3CDTF">2014-01-29T06:00:50Z</dcterms:modified>
</cp:coreProperties>
</file>